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2" r:id="rId2"/>
    <p:sldId id="263" r:id="rId3"/>
  </p:sldIdLst>
  <p:sldSz cx="13716000" cy="109728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4" d="100"/>
          <a:sy n="54" d="100"/>
        </p:scale>
        <p:origin x="155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1795781"/>
            <a:ext cx="11658600" cy="3820160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5763261"/>
            <a:ext cx="10287000" cy="2649219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524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57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584200"/>
            <a:ext cx="2957513" cy="92989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584200"/>
            <a:ext cx="8701088" cy="92989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344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911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2735583"/>
            <a:ext cx="11830050" cy="4564379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7343143"/>
            <a:ext cx="11830050" cy="2400299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/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239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2921000"/>
            <a:ext cx="582930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2921000"/>
            <a:ext cx="582930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75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584202"/>
            <a:ext cx="11830050" cy="21209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2689861"/>
            <a:ext cx="5802510" cy="1318259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4008120"/>
            <a:ext cx="5802510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2689861"/>
            <a:ext cx="5831087" cy="1318259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4008120"/>
            <a:ext cx="5831087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526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678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981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31520"/>
            <a:ext cx="4423767" cy="256032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1579882"/>
            <a:ext cx="6943725" cy="7797800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3291840"/>
            <a:ext cx="4423767" cy="6098541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157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31520"/>
            <a:ext cx="4423767" cy="256032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1579882"/>
            <a:ext cx="6943725" cy="7797800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3291840"/>
            <a:ext cx="4423767" cy="6098541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225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584202"/>
            <a:ext cx="11830050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2921000"/>
            <a:ext cx="11830050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10170162"/>
            <a:ext cx="308610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510FB-72E0-4CC1-8FFA-32CE1E02D511}" type="datetimeFigureOut">
              <a:rPr lang="en-US" smtClean="0"/>
              <a:t>1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10170162"/>
            <a:ext cx="462915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10170162"/>
            <a:ext cx="308610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03057-3905-44D8-8B21-818F225C1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193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5976762-5E93-FF84-31D3-C5EEF0F6E47E}"/>
              </a:ext>
            </a:extLst>
          </p:cNvPr>
          <p:cNvGrpSpPr/>
          <p:nvPr/>
        </p:nvGrpSpPr>
        <p:grpSpPr>
          <a:xfrm>
            <a:off x="1264008" y="579121"/>
            <a:ext cx="11169084" cy="9311639"/>
            <a:chOff x="398076" y="170480"/>
            <a:chExt cx="6186624" cy="491804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F3D7A09-1E8E-40AD-2F0F-5D34FB20FF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527" t="2258" r="7573" b="4035"/>
            <a:stretch/>
          </p:blipFill>
          <p:spPr>
            <a:xfrm>
              <a:off x="442903" y="170480"/>
              <a:ext cx="6141797" cy="4824299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443A29D-3BCC-3790-4CAD-6D69BCC9E1D2}"/>
                </a:ext>
              </a:extLst>
            </p:cNvPr>
            <p:cNvSpPr txBox="1"/>
            <p:nvPr/>
          </p:nvSpPr>
          <p:spPr>
            <a:xfrm rot="5400000">
              <a:off x="62168" y="1870503"/>
              <a:ext cx="989915" cy="3181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1467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11320FC-6EB6-1CB2-89BE-9DDDCCF20620}"/>
                </a:ext>
              </a:extLst>
            </p:cNvPr>
            <p:cNvSpPr txBox="1"/>
            <p:nvPr/>
          </p:nvSpPr>
          <p:spPr>
            <a:xfrm>
              <a:off x="1630387" y="4611374"/>
              <a:ext cx="989915" cy="3181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1467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70E9B19-9698-FA67-B598-82CF91ABFFDB}"/>
                </a:ext>
              </a:extLst>
            </p:cNvPr>
            <p:cNvSpPr txBox="1"/>
            <p:nvPr/>
          </p:nvSpPr>
          <p:spPr>
            <a:xfrm>
              <a:off x="5057485" y="4770424"/>
              <a:ext cx="989915" cy="3181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1467" dirty="0"/>
            </a:p>
          </p:txBody>
        </p:sp>
      </p:grpSp>
      <p:sp>
        <p:nvSpPr>
          <p:cNvPr id="33" name="Rectangle 1">
            <a:extLst>
              <a:ext uri="{FF2B5EF4-FFF2-40B4-BE49-F238E27FC236}">
                <a16:creationId xmlns:a16="http://schemas.microsoft.com/office/drawing/2014/main" id="{47F9672E-2A5B-1166-5804-3052C5650C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7254" y="9940759"/>
            <a:ext cx="12341492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kumimoji="0" 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</a:t>
            </a:r>
            <a:r>
              <a:rPr kumimoji="0" lang="en-US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g.</a:t>
            </a:r>
            <a:r>
              <a:rPr kumimoji="0" lang="en-US" b="1" i="0" u="none" strike="noStrike" cap="none" normalizeH="0" dirty="0" bmk="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S1. </a:t>
            </a:r>
            <a:r>
              <a: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LS </a:t>
            </a:r>
            <a:r>
              <a:rPr lang="en-US" sz="1800" b="1" dirty="0">
                <a:latin typeface="Times New Roman" pitchFamily="18" charset="0"/>
                <a:cs typeface="Times New Roman" pitchFamily="18" charset="0"/>
              </a:rPr>
              <a:t>scores plot for the first 3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latent variables of the </a:t>
            </a:r>
            <a:r>
              <a:rPr lang="en-US" sz="1800" b="1" dirty="0">
                <a:latin typeface="Times New Roman" pitchFamily="18" charset="0"/>
                <a:cs typeface="Times New Roman" pitchFamily="18" charset="0"/>
              </a:rPr>
              <a:t>mean centered 25 samples matrix of the 5-level 4-factor experimental design.</a:t>
            </a:r>
            <a:endParaRPr kumimoji="0" lang="en-US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3458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77E0BF52-05D9-7E9D-796B-CBF90E519A21}"/>
              </a:ext>
            </a:extLst>
          </p:cNvPr>
          <p:cNvGrpSpPr/>
          <p:nvPr/>
        </p:nvGrpSpPr>
        <p:grpSpPr>
          <a:xfrm>
            <a:off x="3716688" y="5137601"/>
            <a:ext cx="6263723" cy="5216306"/>
            <a:chOff x="7319453" y="5147689"/>
            <a:chExt cx="6263723" cy="5216306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EDFB1C4-E8B1-23B9-A980-7A812B25B9C7}"/>
                </a:ext>
              </a:extLst>
            </p:cNvPr>
            <p:cNvSpPr txBox="1"/>
            <p:nvPr/>
          </p:nvSpPr>
          <p:spPr>
            <a:xfrm rot="16200000">
              <a:off x="7059827" y="7218518"/>
              <a:ext cx="898908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67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V 3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990B1E4-AD65-B0E8-6C2D-1D86BF23939A}"/>
                </a:ext>
              </a:extLst>
            </p:cNvPr>
            <p:cNvSpPr txBox="1"/>
            <p:nvPr/>
          </p:nvSpPr>
          <p:spPr>
            <a:xfrm>
              <a:off x="9960902" y="9984339"/>
              <a:ext cx="1703019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67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ble No.</a:t>
              </a:r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099B5D4D-EC96-D8EC-0586-A9C0C13B5C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810" t="2701" r="8517" b="5629"/>
            <a:stretch/>
          </p:blipFill>
          <p:spPr>
            <a:xfrm>
              <a:off x="7652007" y="5147689"/>
              <a:ext cx="5931169" cy="4873567"/>
            </a:xfrm>
            <a:prstGeom prst="rect">
              <a:avLst/>
            </a:prstGeom>
          </p:spPr>
        </p:pic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297EA29A-6130-1CCD-F497-13DBEAA35C5F}"/>
              </a:ext>
            </a:extLst>
          </p:cNvPr>
          <p:cNvGrpSpPr/>
          <p:nvPr/>
        </p:nvGrpSpPr>
        <p:grpSpPr>
          <a:xfrm>
            <a:off x="487976" y="152413"/>
            <a:ext cx="6163863" cy="5108406"/>
            <a:chOff x="6708471" y="76200"/>
            <a:chExt cx="6163863" cy="5108406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468B0202-7FA5-2AC2-8558-EFAE839529B4}"/>
                </a:ext>
              </a:extLst>
            </p:cNvPr>
            <p:cNvGrpSpPr/>
            <p:nvPr/>
          </p:nvGrpSpPr>
          <p:grpSpPr>
            <a:xfrm>
              <a:off x="6708471" y="76200"/>
              <a:ext cx="6163863" cy="5108406"/>
              <a:chOff x="7272351" y="76200"/>
              <a:chExt cx="6163863" cy="5108406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F4D76945-66D5-F6C6-ADA3-ECBC3DE0319C}"/>
                  </a:ext>
                </a:extLst>
              </p:cNvPr>
              <p:cNvSpPr txBox="1"/>
              <p:nvPr/>
            </p:nvSpPr>
            <p:spPr>
              <a:xfrm rot="16200000">
                <a:off x="7012725" y="2058512"/>
                <a:ext cx="898908" cy="3796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867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V 1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28A03768-EBE8-0CA7-570C-77324A4FBF50}"/>
                  </a:ext>
                </a:extLst>
              </p:cNvPr>
              <p:cNvSpPr txBox="1"/>
              <p:nvPr/>
            </p:nvSpPr>
            <p:spPr>
              <a:xfrm>
                <a:off x="9808502" y="4804950"/>
                <a:ext cx="1703019" cy="3796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867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iable No.</a:t>
                </a:r>
              </a:p>
            </p:txBody>
          </p: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BF8784AE-D3CC-1080-F7E2-D066193DA03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548" t="5168" r="8858" b="5809"/>
              <a:stretch/>
            </p:blipFill>
            <p:spPr>
              <a:xfrm>
                <a:off x="7645365" y="76200"/>
                <a:ext cx="5790849" cy="4738540"/>
              </a:xfrm>
              <a:prstGeom prst="rect">
                <a:avLst/>
              </a:prstGeom>
            </p:spPr>
          </p:pic>
        </p:grp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08B30A6-8D34-996A-4FBC-46DB192521E0}"/>
                </a:ext>
              </a:extLst>
            </p:cNvPr>
            <p:cNvSpPr txBox="1"/>
            <p:nvPr/>
          </p:nvSpPr>
          <p:spPr>
            <a:xfrm>
              <a:off x="11724881" y="229921"/>
              <a:ext cx="939559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67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112614E0-6FC3-4FD5-209B-0B77810BE8AC}"/>
              </a:ext>
            </a:extLst>
          </p:cNvPr>
          <p:cNvGrpSpPr/>
          <p:nvPr/>
        </p:nvGrpSpPr>
        <p:grpSpPr>
          <a:xfrm>
            <a:off x="6932511" y="185420"/>
            <a:ext cx="6242399" cy="5092648"/>
            <a:chOff x="487976" y="5215319"/>
            <a:chExt cx="6242399" cy="5092648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EF81373B-211F-B80C-7BE2-9FD66DAED2A1}"/>
                </a:ext>
              </a:extLst>
            </p:cNvPr>
            <p:cNvGrpSpPr/>
            <p:nvPr/>
          </p:nvGrpSpPr>
          <p:grpSpPr>
            <a:xfrm>
              <a:off x="487976" y="5215319"/>
              <a:ext cx="6242399" cy="5092648"/>
              <a:chOff x="-14944" y="5215319"/>
              <a:chExt cx="6242399" cy="5092648"/>
            </a:xfrm>
          </p:grpSpPr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164801B9-9D10-4999-9BE4-440487D3188B}"/>
                  </a:ext>
                </a:extLst>
              </p:cNvPr>
              <p:cNvSpPr txBox="1"/>
              <p:nvPr/>
            </p:nvSpPr>
            <p:spPr>
              <a:xfrm rot="16200000">
                <a:off x="-274570" y="7264022"/>
                <a:ext cx="898908" cy="3796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867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V 2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EBD1D85B-8ED9-BEC9-72CA-EBAE7C152839}"/>
                  </a:ext>
                </a:extLst>
              </p:cNvPr>
              <p:cNvSpPr txBox="1"/>
              <p:nvPr/>
            </p:nvSpPr>
            <p:spPr>
              <a:xfrm>
                <a:off x="2620302" y="9928311"/>
                <a:ext cx="1703019" cy="3796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867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iable No.</a:t>
                </a:r>
              </a:p>
            </p:txBody>
          </p:sp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97BCCFC2-0EB6-46E2-49D6-57C4AA83C8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8857" t="5428" r="8000" b="5810"/>
              <a:stretch/>
            </p:blipFill>
            <p:spPr>
              <a:xfrm>
                <a:off x="364712" y="5215319"/>
                <a:ext cx="5862743" cy="4738540"/>
              </a:xfrm>
              <a:prstGeom prst="rect">
                <a:avLst/>
              </a:prstGeom>
            </p:spPr>
          </p:pic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4E6786C-0558-6A1B-7D6E-7CAC64E23CA6}"/>
                </a:ext>
              </a:extLst>
            </p:cNvPr>
            <p:cNvSpPr txBox="1"/>
            <p:nvPr/>
          </p:nvSpPr>
          <p:spPr>
            <a:xfrm>
              <a:off x="5533125" y="5351125"/>
              <a:ext cx="939559" cy="379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67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73EA9AE0-CB24-ADF6-F34B-5DA294FCD106}"/>
              </a:ext>
            </a:extLst>
          </p:cNvPr>
          <p:cNvSpPr txBox="1"/>
          <p:nvPr/>
        </p:nvSpPr>
        <p:spPr>
          <a:xfrm>
            <a:off x="8802682" y="5402796"/>
            <a:ext cx="939559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6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8" name="Rectangle 1">
            <a:extLst>
              <a:ext uri="{FF2B5EF4-FFF2-40B4-BE49-F238E27FC236}">
                <a16:creationId xmlns:a16="http://schemas.microsoft.com/office/drawing/2014/main" id="{10EEAB18-8AA8-6327-31D3-554AC650B5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990" y="10295936"/>
            <a:ext cx="12341492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kumimoji="0" 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</a:t>
            </a:r>
            <a:r>
              <a:rPr kumimoji="0" lang="en-US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g.</a:t>
            </a:r>
            <a:r>
              <a:rPr kumimoji="0" lang="en-US" b="1" i="0" u="none" strike="noStrike" cap="none" normalizeH="0" dirty="0" bmk="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S2. </a:t>
            </a:r>
            <a:r>
              <a:rPr kumimoji="0" lang="en-US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LS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Loading plots for </a:t>
            </a:r>
            <a:r>
              <a:rPr lang="en-US" sz="1800" b="1" dirty="0">
                <a:latin typeface="Times New Roman" pitchFamily="18" charset="0"/>
                <a:cs typeface="Times New Roman" pitchFamily="18" charset="0"/>
              </a:rPr>
              <a:t>the first 3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latent variables of the 130 wavelengths used for construction of the models, a) LV1, b) LV2, and c) LV3.  </a:t>
            </a:r>
            <a:endParaRPr kumimoji="0" lang="en-US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5738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</TotalTime>
  <Words>82</Words>
  <Application>Microsoft Office PowerPoint</Application>
  <PresentationFormat>Custom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id A. Hassan</dc:creator>
  <cp:lastModifiedBy>Said A. Hassan</cp:lastModifiedBy>
  <cp:revision>3</cp:revision>
  <dcterms:created xsi:type="dcterms:W3CDTF">2023-11-26T03:46:43Z</dcterms:created>
  <dcterms:modified xsi:type="dcterms:W3CDTF">2023-12-19T18:29:54Z</dcterms:modified>
</cp:coreProperties>
</file>